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sldIdLst>
    <p:sldId id="256" r:id="rId2"/>
  </p:sldIdLst>
  <p:sldSz cx="6480175" cy="46085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25" autoAdjust="0"/>
    <p:restoredTop sz="97436" autoAdjust="0"/>
  </p:normalViewPr>
  <p:slideViewPr>
    <p:cSldViewPr snapToGrid="0">
      <p:cViewPr varScale="1">
        <p:scale>
          <a:sx n="232" d="100"/>
          <a:sy n="232" d="100"/>
        </p:scale>
        <p:origin x="499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754218"/>
            <a:ext cx="5508149" cy="1604445"/>
          </a:xfrm>
        </p:spPr>
        <p:txBody>
          <a:bodyPr anchor="b"/>
          <a:lstStyle>
            <a:lvl1pPr algn="ctr">
              <a:defRPr sz="403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2420536"/>
            <a:ext cx="4860131" cy="1112657"/>
          </a:xfrm>
        </p:spPr>
        <p:txBody>
          <a:bodyPr/>
          <a:lstStyle>
            <a:lvl1pPr marL="0" indent="0" algn="ctr">
              <a:buNone/>
              <a:defRPr sz="1613"/>
            </a:lvl1pPr>
            <a:lvl2pPr marL="307238" indent="0" algn="ctr">
              <a:buNone/>
              <a:defRPr sz="1344"/>
            </a:lvl2pPr>
            <a:lvl3pPr marL="614477" indent="0" algn="ctr">
              <a:buNone/>
              <a:defRPr sz="1210"/>
            </a:lvl3pPr>
            <a:lvl4pPr marL="921715" indent="0" algn="ctr">
              <a:buNone/>
              <a:defRPr sz="1075"/>
            </a:lvl4pPr>
            <a:lvl5pPr marL="1228954" indent="0" algn="ctr">
              <a:buNone/>
              <a:defRPr sz="1075"/>
            </a:lvl5pPr>
            <a:lvl6pPr marL="1536192" indent="0" algn="ctr">
              <a:buNone/>
              <a:defRPr sz="1075"/>
            </a:lvl6pPr>
            <a:lvl7pPr marL="1843430" indent="0" algn="ctr">
              <a:buNone/>
              <a:defRPr sz="1075"/>
            </a:lvl7pPr>
            <a:lvl8pPr marL="2150669" indent="0" algn="ctr">
              <a:buNone/>
              <a:defRPr sz="1075"/>
            </a:lvl8pPr>
            <a:lvl9pPr marL="2457907" indent="0" algn="ctr">
              <a:buNone/>
              <a:defRPr sz="107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2245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3265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245361"/>
            <a:ext cx="1397288" cy="39055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245361"/>
            <a:ext cx="4110861" cy="39055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728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923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1148929"/>
            <a:ext cx="5589151" cy="1917013"/>
          </a:xfrm>
        </p:spPr>
        <p:txBody>
          <a:bodyPr anchor="b"/>
          <a:lstStyle>
            <a:lvl1pPr>
              <a:defRPr sz="403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3084078"/>
            <a:ext cx="5589151" cy="1008112"/>
          </a:xfrm>
        </p:spPr>
        <p:txBody>
          <a:bodyPr/>
          <a:lstStyle>
            <a:lvl1pPr marL="0" indent="0">
              <a:buNone/>
              <a:defRPr sz="1613">
                <a:solidFill>
                  <a:schemeClr val="tx1"/>
                </a:solidFill>
              </a:defRPr>
            </a:lvl1pPr>
            <a:lvl2pPr marL="307238" indent="0">
              <a:buNone/>
              <a:defRPr sz="1344">
                <a:solidFill>
                  <a:schemeClr val="tx1">
                    <a:tint val="75000"/>
                  </a:schemeClr>
                </a:solidFill>
              </a:defRPr>
            </a:lvl2pPr>
            <a:lvl3pPr marL="614477" indent="0">
              <a:buNone/>
              <a:defRPr sz="1210">
                <a:solidFill>
                  <a:schemeClr val="tx1">
                    <a:tint val="75000"/>
                  </a:schemeClr>
                </a:solidFill>
              </a:defRPr>
            </a:lvl3pPr>
            <a:lvl4pPr marL="921715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4pPr>
            <a:lvl5pPr marL="1228954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5pPr>
            <a:lvl6pPr marL="1536192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6pPr>
            <a:lvl7pPr marL="1843430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7pPr>
            <a:lvl8pPr marL="2150669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8pPr>
            <a:lvl9pPr marL="2457907" indent="0">
              <a:buNone/>
              <a:defRPr sz="10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6652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1226803"/>
            <a:ext cx="2754074" cy="29240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1226803"/>
            <a:ext cx="2754074" cy="29240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768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245362"/>
            <a:ext cx="5589151" cy="89076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1129726"/>
            <a:ext cx="2741417" cy="553661"/>
          </a:xfrm>
        </p:spPr>
        <p:txBody>
          <a:bodyPr anchor="b"/>
          <a:lstStyle>
            <a:lvl1pPr marL="0" indent="0">
              <a:buNone/>
              <a:defRPr sz="1613" b="1"/>
            </a:lvl1pPr>
            <a:lvl2pPr marL="307238" indent="0">
              <a:buNone/>
              <a:defRPr sz="1344" b="1"/>
            </a:lvl2pPr>
            <a:lvl3pPr marL="614477" indent="0">
              <a:buNone/>
              <a:defRPr sz="1210" b="1"/>
            </a:lvl3pPr>
            <a:lvl4pPr marL="921715" indent="0">
              <a:buNone/>
              <a:defRPr sz="1075" b="1"/>
            </a:lvl4pPr>
            <a:lvl5pPr marL="1228954" indent="0">
              <a:buNone/>
              <a:defRPr sz="1075" b="1"/>
            </a:lvl5pPr>
            <a:lvl6pPr marL="1536192" indent="0">
              <a:buNone/>
              <a:defRPr sz="1075" b="1"/>
            </a:lvl6pPr>
            <a:lvl7pPr marL="1843430" indent="0">
              <a:buNone/>
              <a:defRPr sz="1075" b="1"/>
            </a:lvl7pPr>
            <a:lvl8pPr marL="2150669" indent="0">
              <a:buNone/>
              <a:defRPr sz="1075" b="1"/>
            </a:lvl8pPr>
            <a:lvl9pPr marL="2457907" indent="0">
              <a:buNone/>
              <a:defRPr sz="10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1683388"/>
            <a:ext cx="2741417" cy="24760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1129726"/>
            <a:ext cx="2754918" cy="553661"/>
          </a:xfrm>
        </p:spPr>
        <p:txBody>
          <a:bodyPr anchor="b"/>
          <a:lstStyle>
            <a:lvl1pPr marL="0" indent="0">
              <a:buNone/>
              <a:defRPr sz="1613" b="1"/>
            </a:lvl1pPr>
            <a:lvl2pPr marL="307238" indent="0">
              <a:buNone/>
              <a:defRPr sz="1344" b="1"/>
            </a:lvl2pPr>
            <a:lvl3pPr marL="614477" indent="0">
              <a:buNone/>
              <a:defRPr sz="1210" b="1"/>
            </a:lvl3pPr>
            <a:lvl4pPr marL="921715" indent="0">
              <a:buNone/>
              <a:defRPr sz="1075" b="1"/>
            </a:lvl4pPr>
            <a:lvl5pPr marL="1228954" indent="0">
              <a:buNone/>
              <a:defRPr sz="1075" b="1"/>
            </a:lvl5pPr>
            <a:lvl6pPr marL="1536192" indent="0">
              <a:buNone/>
              <a:defRPr sz="1075" b="1"/>
            </a:lvl6pPr>
            <a:lvl7pPr marL="1843430" indent="0">
              <a:buNone/>
              <a:defRPr sz="1075" b="1"/>
            </a:lvl7pPr>
            <a:lvl8pPr marL="2150669" indent="0">
              <a:buNone/>
              <a:defRPr sz="1075" b="1"/>
            </a:lvl8pPr>
            <a:lvl9pPr marL="2457907" indent="0">
              <a:buNone/>
              <a:defRPr sz="10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1683388"/>
            <a:ext cx="2754918" cy="24760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9431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6911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540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07234"/>
            <a:ext cx="2090025" cy="1075320"/>
          </a:xfrm>
        </p:spPr>
        <p:txBody>
          <a:bodyPr anchor="b"/>
          <a:lstStyle>
            <a:lvl1pPr>
              <a:defRPr sz="21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663542"/>
            <a:ext cx="3280589" cy="3275031"/>
          </a:xfrm>
        </p:spPr>
        <p:txBody>
          <a:bodyPr/>
          <a:lstStyle>
            <a:lvl1pPr>
              <a:defRPr sz="2150"/>
            </a:lvl1pPr>
            <a:lvl2pPr>
              <a:defRPr sz="1882"/>
            </a:lvl2pPr>
            <a:lvl3pPr>
              <a:defRPr sz="1613"/>
            </a:lvl3pPr>
            <a:lvl4pPr>
              <a:defRPr sz="1344"/>
            </a:lvl4pPr>
            <a:lvl5pPr>
              <a:defRPr sz="1344"/>
            </a:lvl5pPr>
            <a:lvl6pPr>
              <a:defRPr sz="1344"/>
            </a:lvl6pPr>
            <a:lvl7pPr>
              <a:defRPr sz="1344"/>
            </a:lvl7pPr>
            <a:lvl8pPr>
              <a:defRPr sz="1344"/>
            </a:lvl8pPr>
            <a:lvl9pPr>
              <a:defRPr sz="134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382554"/>
            <a:ext cx="2090025" cy="2561352"/>
          </a:xfrm>
        </p:spPr>
        <p:txBody>
          <a:bodyPr/>
          <a:lstStyle>
            <a:lvl1pPr marL="0" indent="0">
              <a:buNone/>
              <a:defRPr sz="1075"/>
            </a:lvl1pPr>
            <a:lvl2pPr marL="307238" indent="0">
              <a:buNone/>
              <a:defRPr sz="941"/>
            </a:lvl2pPr>
            <a:lvl3pPr marL="614477" indent="0">
              <a:buNone/>
              <a:defRPr sz="806"/>
            </a:lvl3pPr>
            <a:lvl4pPr marL="921715" indent="0">
              <a:buNone/>
              <a:defRPr sz="672"/>
            </a:lvl4pPr>
            <a:lvl5pPr marL="1228954" indent="0">
              <a:buNone/>
              <a:defRPr sz="672"/>
            </a:lvl5pPr>
            <a:lvl6pPr marL="1536192" indent="0">
              <a:buNone/>
              <a:defRPr sz="672"/>
            </a:lvl6pPr>
            <a:lvl7pPr marL="1843430" indent="0">
              <a:buNone/>
              <a:defRPr sz="672"/>
            </a:lvl7pPr>
            <a:lvl8pPr marL="2150669" indent="0">
              <a:buNone/>
              <a:defRPr sz="672"/>
            </a:lvl8pPr>
            <a:lvl9pPr marL="2457907" indent="0">
              <a:buNone/>
              <a:defRPr sz="6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546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307234"/>
            <a:ext cx="2090025" cy="1075320"/>
          </a:xfrm>
        </p:spPr>
        <p:txBody>
          <a:bodyPr anchor="b"/>
          <a:lstStyle>
            <a:lvl1pPr>
              <a:defRPr sz="215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663542"/>
            <a:ext cx="3280589" cy="3275031"/>
          </a:xfrm>
        </p:spPr>
        <p:txBody>
          <a:bodyPr anchor="t"/>
          <a:lstStyle>
            <a:lvl1pPr marL="0" indent="0">
              <a:buNone/>
              <a:defRPr sz="2150"/>
            </a:lvl1pPr>
            <a:lvl2pPr marL="307238" indent="0">
              <a:buNone/>
              <a:defRPr sz="1882"/>
            </a:lvl2pPr>
            <a:lvl3pPr marL="614477" indent="0">
              <a:buNone/>
              <a:defRPr sz="1613"/>
            </a:lvl3pPr>
            <a:lvl4pPr marL="921715" indent="0">
              <a:buNone/>
              <a:defRPr sz="1344"/>
            </a:lvl4pPr>
            <a:lvl5pPr marL="1228954" indent="0">
              <a:buNone/>
              <a:defRPr sz="1344"/>
            </a:lvl5pPr>
            <a:lvl6pPr marL="1536192" indent="0">
              <a:buNone/>
              <a:defRPr sz="1344"/>
            </a:lvl6pPr>
            <a:lvl7pPr marL="1843430" indent="0">
              <a:buNone/>
              <a:defRPr sz="1344"/>
            </a:lvl7pPr>
            <a:lvl8pPr marL="2150669" indent="0">
              <a:buNone/>
              <a:defRPr sz="1344"/>
            </a:lvl8pPr>
            <a:lvl9pPr marL="2457907" indent="0">
              <a:buNone/>
              <a:defRPr sz="134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1382554"/>
            <a:ext cx="2090025" cy="2561352"/>
          </a:xfrm>
        </p:spPr>
        <p:txBody>
          <a:bodyPr/>
          <a:lstStyle>
            <a:lvl1pPr marL="0" indent="0">
              <a:buNone/>
              <a:defRPr sz="1075"/>
            </a:lvl1pPr>
            <a:lvl2pPr marL="307238" indent="0">
              <a:buNone/>
              <a:defRPr sz="941"/>
            </a:lvl2pPr>
            <a:lvl3pPr marL="614477" indent="0">
              <a:buNone/>
              <a:defRPr sz="806"/>
            </a:lvl3pPr>
            <a:lvl4pPr marL="921715" indent="0">
              <a:buNone/>
              <a:defRPr sz="672"/>
            </a:lvl4pPr>
            <a:lvl5pPr marL="1228954" indent="0">
              <a:buNone/>
              <a:defRPr sz="672"/>
            </a:lvl5pPr>
            <a:lvl6pPr marL="1536192" indent="0">
              <a:buNone/>
              <a:defRPr sz="672"/>
            </a:lvl6pPr>
            <a:lvl7pPr marL="1843430" indent="0">
              <a:buNone/>
              <a:defRPr sz="672"/>
            </a:lvl7pPr>
            <a:lvl8pPr marL="2150669" indent="0">
              <a:buNone/>
              <a:defRPr sz="672"/>
            </a:lvl8pPr>
            <a:lvl9pPr marL="2457907" indent="0">
              <a:buNone/>
              <a:defRPr sz="6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77530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245362"/>
            <a:ext cx="5589151" cy="89076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1226803"/>
            <a:ext cx="5589151" cy="29240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4271410"/>
            <a:ext cx="1458039" cy="2453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4271410"/>
            <a:ext cx="2187059" cy="2453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4271410"/>
            <a:ext cx="1458039" cy="2453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050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614477" rtl="0" eaLnBrk="1" latinLnBrk="0" hangingPunct="1">
        <a:lnSpc>
          <a:spcPct val="90000"/>
        </a:lnSpc>
        <a:spcBef>
          <a:spcPct val="0"/>
        </a:spcBef>
        <a:buNone/>
        <a:defRPr sz="295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619" indent="-153619" algn="l" defTabSz="614477" rtl="0" eaLnBrk="1" latinLnBrk="0" hangingPunct="1">
        <a:lnSpc>
          <a:spcPct val="90000"/>
        </a:lnSpc>
        <a:spcBef>
          <a:spcPts val="672"/>
        </a:spcBef>
        <a:buFont typeface="Arial" panose="020B0604020202020204" pitchFamily="34" charset="0"/>
        <a:buChar char="•"/>
        <a:defRPr sz="1882" kern="1200">
          <a:solidFill>
            <a:schemeClr val="tx1"/>
          </a:solidFill>
          <a:latin typeface="+mn-lt"/>
          <a:ea typeface="+mn-ea"/>
          <a:cs typeface="+mn-cs"/>
        </a:defRPr>
      </a:lvl1pPr>
      <a:lvl2pPr marL="460858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613" kern="1200">
          <a:solidFill>
            <a:schemeClr val="tx1"/>
          </a:solidFill>
          <a:latin typeface="+mn-lt"/>
          <a:ea typeface="+mn-ea"/>
          <a:cs typeface="+mn-cs"/>
        </a:defRPr>
      </a:lvl2pPr>
      <a:lvl3pPr marL="768096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344" kern="1200">
          <a:solidFill>
            <a:schemeClr val="tx1"/>
          </a:solidFill>
          <a:latin typeface="+mn-lt"/>
          <a:ea typeface="+mn-ea"/>
          <a:cs typeface="+mn-cs"/>
        </a:defRPr>
      </a:lvl3pPr>
      <a:lvl4pPr marL="1075334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10" kern="1200">
          <a:solidFill>
            <a:schemeClr val="tx1"/>
          </a:solidFill>
          <a:latin typeface="+mn-lt"/>
          <a:ea typeface="+mn-ea"/>
          <a:cs typeface="+mn-cs"/>
        </a:defRPr>
      </a:lvl4pPr>
      <a:lvl5pPr marL="1382573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10" kern="1200">
          <a:solidFill>
            <a:schemeClr val="tx1"/>
          </a:solidFill>
          <a:latin typeface="+mn-lt"/>
          <a:ea typeface="+mn-ea"/>
          <a:cs typeface="+mn-cs"/>
        </a:defRPr>
      </a:lvl5pPr>
      <a:lvl6pPr marL="1689811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10" kern="1200">
          <a:solidFill>
            <a:schemeClr val="tx1"/>
          </a:solidFill>
          <a:latin typeface="+mn-lt"/>
          <a:ea typeface="+mn-ea"/>
          <a:cs typeface="+mn-cs"/>
        </a:defRPr>
      </a:lvl6pPr>
      <a:lvl7pPr marL="1997050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10" kern="1200">
          <a:solidFill>
            <a:schemeClr val="tx1"/>
          </a:solidFill>
          <a:latin typeface="+mn-lt"/>
          <a:ea typeface="+mn-ea"/>
          <a:cs typeface="+mn-cs"/>
        </a:defRPr>
      </a:lvl7pPr>
      <a:lvl8pPr marL="2304288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10" kern="1200">
          <a:solidFill>
            <a:schemeClr val="tx1"/>
          </a:solidFill>
          <a:latin typeface="+mn-lt"/>
          <a:ea typeface="+mn-ea"/>
          <a:cs typeface="+mn-cs"/>
        </a:defRPr>
      </a:lvl8pPr>
      <a:lvl9pPr marL="2611526" indent="-153619" algn="l" defTabSz="614477" rtl="0" eaLnBrk="1" latinLnBrk="0" hangingPunct="1">
        <a:lnSpc>
          <a:spcPct val="90000"/>
        </a:lnSpc>
        <a:spcBef>
          <a:spcPts val="336"/>
        </a:spcBef>
        <a:buFont typeface="Arial" panose="020B0604020202020204" pitchFamily="34" charset="0"/>
        <a:buChar char="•"/>
        <a:defRPr sz="121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1pPr>
      <a:lvl2pPr marL="307238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2pPr>
      <a:lvl3pPr marL="614477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3pPr>
      <a:lvl4pPr marL="921715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4pPr>
      <a:lvl5pPr marL="1228954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5pPr>
      <a:lvl6pPr marL="1536192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6pPr>
      <a:lvl7pPr marL="1843430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7pPr>
      <a:lvl8pPr marL="2150669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8pPr>
      <a:lvl9pPr marL="2457907" algn="l" defTabSz="614477" rtl="0" eaLnBrk="1" latinLnBrk="0" hangingPunct="1">
        <a:defRPr sz="121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emf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emf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图片 48">
            <a:extLst>
              <a:ext uri="{FF2B5EF4-FFF2-40B4-BE49-F238E27FC236}">
                <a16:creationId xmlns:a16="http://schemas.microsoft.com/office/drawing/2014/main" id="{A46C11A6-623C-4E91-8E4D-739BD9A53D1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10" t="41743" r="60461" b="37409"/>
          <a:stretch/>
        </p:blipFill>
        <p:spPr>
          <a:xfrm>
            <a:off x="3448007" y="3615270"/>
            <a:ext cx="954468" cy="960709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B33921A4-D590-4E34-A43C-566CC2935B6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32" t="13543" r="39538" b="65745"/>
          <a:stretch/>
        </p:blipFill>
        <p:spPr>
          <a:xfrm>
            <a:off x="3432436" y="1314349"/>
            <a:ext cx="954467" cy="954467"/>
          </a:xfrm>
          <a:prstGeom prst="rect">
            <a:avLst/>
          </a:prstGeom>
        </p:spPr>
      </p:pic>
      <p:sp>
        <p:nvSpPr>
          <p:cNvPr id="52" name="文本框 51">
            <a:extLst>
              <a:ext uri="{FF2B5EF4-FFF2-40B4-BE49-F238E27FC236}">
                <a16:creationId xmlns:a16="http://schemas.microsoft.com/office/drawing/2014/main" id="{B58C4B78-C00E-4CCB-B0E0-FFEBD5FA7DD0}"/>
              </a:ext>
            </a:extLst>
          </p:cNvPr>
          <p:cNvSpPr txBox="1"/>
          <p:nvPr/>
        </p:nvSpPr>
        <p:spPr>
          <a:xfrm>
            <a:off x="-33131" y="-5693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617E6A1-3FE5-46A3-8A01-B80D3017628E}"/>
              </a:ext>
            </a:extLst>
          </p:cNvPr>
          <p:cNvSpPr txBox="1"/>
          <p:nvPr/>
        </p:nvSpPr>
        <p:spPr>
          <a:xfrm>
            <a:off x="-67371" y="682464"/>
            <a:ext cx="4699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9F0EA1CD-80F0-4CB8-AEC1-4BBE2323E1CC}"/>
              </a:ext>
            </a:extLst>
          </p:cNvPr>
          <p:cNvSpPr txBox="1"/>
          <p:nvPr/>
        </p:nvSpPr>
        <p:spPr>
          <a:xfrm>
            <a:off x="-67364" y="1668817"/>
            <a:ext cx="528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5785C4A6-6DE9-4E86-AFEC-1D5AB261929D}"/>
              </a:ext>
            </a:extLst>
          </p:cNvPr>
          <p:cNvSpPr txBox="1"/>
          <p:nvPr/>
        </p:nvSpPr>
        <p:spPr>
          <a:xfrm>
            <a:off x="879978" y="-44856"/>
            <a:ext cx="95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lomerulu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4A5A772F-AC70-419E-AF1A-9F5596754C24}"/>
              </a:ext>
            </a:extLst>
          </p:cNvPr>
          <p:cNvCxnSpPr>
            <a:cxnSpLocks/>
          </p:cNvCxnSpPr>
          <p:nvPr/>
        </p:nvCxnSpPr>
        <p:spPr>
          <a:xfrm>
            <a:off x="546100" y="155753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539FFC00-7BC4-4D68-8950-7EA72F4B1BFD}"/>
              </a:ext>
            </a:extLst>
          </p:cNvPr>
          <p:cNvSpPr txBox="1"/>
          <p:nvPr/>
        </p:nvSpPr>
        <p:spPr>
          <a:xfrm>
            <a:off x="461520" y="121738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E83F367-DFC0-4F75-8EEB-3C9A62503BDC}"/>
              </a:ext>
            </a:extLst>
          </p:cNvPr>
          <p:cNvSpPr txBox="1"/>
          <p:nvPr/>
        </p:nvSpPr>
        <p:spPr>
          <a:xfrm>
            <a:off x="1453802" y="117663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87A90F62-3E73-432F-8DF3-4AF5667AECD0}"/>
              </a:ext>
            </a:extLst>
          </p:cNvPr>
          <p:cNvSpPr txBox="1"/>
          <p:nvPr/>
        </p:nvSpPr>
        <p:spPr>
          <a:xfrm>
            <a:off x="2858395" y="-44856"/>
            <a:ext cx="115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roximal tubul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BD07E4F3-129D-4E9F-9B61-9802827D8C91}"/>
              </a:ext>
            </a:extLst>
          </p:cNvPr>
          <p:cNvCxnSpPr>
            <a:cxnSpLocks/>
          </p:cNvCxnSpPr>
          <p:nvPr/>
        </p:nvCxnSpPr>
        <p:spPr>
          <a:xfrm>
            <a:off x="2600930" y="155753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文本框 78">
            <a:extLst>
              <a:ext uri="{FF2B5EF4-FFF2-40B4-BE49-F238E27FC236}">
                <a16:creationId xmlns:a16="http://schemas.microsoft.com/office/drawing/2014/main" id="{176EFFCF-2FC6-4250-B4D8-96D9B029BB3C}"/>
              </a:ext>
            </a:extLst>
          </p:cNvPr>
          <p:cNvSpPr txBox="1"/>
          <p:nvPr/>
        </p:nvSpPr>
        <p:spPr>
          <a:xfrm>
            <a:off x="2516350" y="121739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B0FCCE0E-D456-4DBB-911C-B16D9DA50328}"/>
              </a:ext>
            </a:extLst>
          </p:cNvPr>
          <p:cNvSpPr txBox="1"/>
          <p:nvPr/>
        </p:nvSpPr>
        <p:spPr>
          <a:xfrm>
            <a:off x="3508631" y="117663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6" name="图片 165">
            <a:extLst>
              <a:ext uri="{FF2B5EF4-FFF2-40B4-BE49-F238E27FC236}">
                <a16:creationId xmlns:a16="http://schemas.microsoft.com/office/drawing/2014/main" id="{8E8FEC85-EF2F-4FF3-892E-7E07D550CF3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90955" y="566820"/>
            <a:ext cx="2276841" cy="1848385"/>
          </a:xfrm>
          <a:prstGeom prst="rect">
            <a:avLst/>
          </a:prstGeom>
        </p:spPr>
      </p:pic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3CD629B-962C-4FF0-9E90-1CEFDC263483}"/>
              </a:ext>
            </a:extLst>
          </p:cNvPr>
          <p:cNvCxnSpPr/>
          <p:nvPr/>
        </p:nvCxnSpPr>
        <p:spPr>
          <a:xfrm>
            <a:off x="3992418" y="2082662"/>
            <a:ext cx="3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CBB8B6CD-5D54-4C94-B72C-8020172602A5}"/>
              </a:ext>
            </a:extLst>
          </p:cNvPr>
          <p:cNvSpPr txBox="1"/>
          <p:nvPr/>
        </p:nvSpPr>
        <p:spPr>
          <a:xfrm>
            <a:off x="3912041" y="2061008"/>
            <a:ext cx="52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r>
              <a:rPr lang="el-GR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940A4FB0-2E03-4F99-BAA2-E4FF0010DAAF}"/>
              </a:ext>
            </a:extLst>
          </p:cNvPr>
          <p:cNvSpPr txBox="1"/>
          <p:nvPr/>
        </p:nvSpPr>
        <p:spPr>
          <a:xfrm>
            <a:off x="-37759" y="224519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9B2EA44E-EA95-4558-81BC-10B72EACD967}"/>
              </a:ext>
            </a:extLst>
          </p:cNvPr>
          <p:cNvSpPr txBox="1"/>
          <p:nvPr/>
        </p:nvSpPr>
        <p:spPr>
          <a:xfrm>
            <a:off x="-67371" y="2984594"/>
            <a:ext cx="4699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5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56CB1162-CB1E-4D54-BA96-B5A3899B85BB}"/>
              </a:ext>
            </a:extLst>
          </p:cNvPr>
          <p:cNvSpPr txBox="1"/>
          <p:nvPr/>
        </p:nvSpPr>
        <p:spPr>
          <a:xfrm>
            <a:off x="-67364" y="3970945"/>
            <a:ext cx="528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14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87ECE528-B368-4DF4-B3FD-FC271DD3B4C1}"/>
              </a:ext>
            </a:extLst>
          </p:cNvPr>
          <p:cNvSpPr txBox="1"/>
          <p:nvPr/>
        </p:nvSpPr>
        <p:spPr>
          <a:xfrm>
            <a:off x="879978" y="2257285"/>
            <a:ext cx="9544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Glomerulus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68D52238-CBDA-436F-BA8B-9B30018A4869}"/>
              </a:ext>
            </a:extLst>
          </p:cNvPr>
          <p:cNvCxnSpPr>
            <a:cxnSpLocks/>
          </p:cNvCxnSpPr>
          <p:nvPr/>
        </p:nvCxnSpPr>
        <p:spPr>
          <a:xfrm>
            <a:off x="546100" y="2457881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文本框 90">
            <a:extLst>
              <a:ext uri="{FF2B5EF4-FFF2-40B4-BE49-F238E27FC236}">
                <a16:creationId xmlns:a16="http://schemas.microsoft.com/office/drawing/2014/main" id="{5116ADB7-7BB6-4B03-AAC1-1D8F792C3E87}"/>
              </a:ext>
            </a:extLst>
          </p:cNvPr>
          <p:cNvSpPr txBox="1"/>
          <p:nvPr/>
        </p:nvSpPr>
        <p:spPr>
          <a:xfrm>
            <a:off x="461520" y="2423876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001B899B-BF53-4EA1-A755-C6BC3329DCFD}"/>
              </a:ext>
            </a:extLst>
          </p:cNvPr>
          <p:cNvSpPr txBox="1"/>
          <p:nvPr/>
        </p:nvSpPr>
        <p:spPr>
          <a:xfrm>
            <a:off x="1453802" y="2419801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DD8C7D2D-267D-4A04-9E30-7FF71386B384}"/>
              </a:ext>
            </a:extLst>
          </p:cNvPr>
          <p:cNvSpPr txBox="1"/>
          <p:nvPr/>
        </p:nvSpPr>
        <p:spPr>
          <a:xfrm>
            <a:off x="2858401" y="2257285"/>
            <a:ext cx="1154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Proximal tubule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id="{E0EFCE02-0192-417E-8A0A-7F6271257750}"/>
              </a:ext>
            </a:extLst>
          </p:cNvPr>
          <p:cNvCxnSpPr>
            <a:cxnSpLocks/>
          </p:cNvCxnSpPr>
          <p:nvPr/>
        </p:nvCxnSpPr>
        <p:spPr>
          <a:xfrm>
            <a:off x="2600930" y="2457881"/>
            <a:ext cx="16192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5" name="文本框 94">
            <a:extLst>
              <a:ext uri="{FF2B5EF4-FFF2-40B4-BE49-F238E27FC236}">
                <a16:creationId xmlns:a16="http://schemas.microsoft.com/office/drawing/2014/main" id="{6FAEA8B8-F546-4129-B85F-11C668E60600}"/>
              </a:ext>
            </a:extLst>
          </p:cNvPr>
          <p:cNvSpPr txBox="1"/>
          <p:nvPr/>
        </p:nvSpPr>
        <p:spPr>
          <a:xfrm>
            <a:off x="2516350" y="2423877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90BFA2D9-F9D8-4B66-9690-0590917C4CC7}"/>
              </a:ext>
            </a:extLst>
          </p:cNvPr>
          <p:cNvSpPr txBox="1"/>
          <p:nvPr/>
        </p:nvSpPr>
        <p:spPr>
          <a:xfrm>
            <a:off x="3508631" y="2419801"/>
            <a:ext cx="802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Hyperoxi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0CB0A5F7-FFB1-450F-98E9-BA2D08BF29EC}"/>
              </a:ext>
            </a:extLst>
          </p:cNvPr>
          <p:cNvCxnSpPr/>
          <p:nvPr/>
        </p:nvCxnSpPr>
        <p:spPr>
          <a:xfrm>
            <a:off x="3994552" y="4346940"/>
            <a:ext cx="3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6" name="文本框 105">
            <a:extLst>
              <a:ext uri="{FF2B5EF4-FFF2-40B4-BE49-F238E27FC236}">
                <a16:creationId xmlns:a16="http://schemas.microsoft.com/office/drawing/2014/main" id="{D81177EE-2029-41BC-924B-88FB19D2BE7A}"/>
              </a:ext>
            </a:extLst>
          </p:cNvPr>
          <p:cNvSpPr txBox="1"/>
          <p:nvPr/>
        </p:nvSpPr>
        <p:spPr>
          <a:xfrm>
            <a:off x="3914175" y="4340358"/>
            <a:ext cx="5207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r>
              <a:rPr lang="el-GR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2" name="图片 111">
            <a:extLst>
              <a:ext uri="{FF2B5EF4-FFF2-40B4-BE49-F238E27FC236}">
                <a16:creationId xmlns:a16="http://schemas.microsoft.com/office/drawing/2014/main" id="{69C24DA9-A800-41D3-84B5-67326FDCF29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372071" y="2816969"/>
            <a:ext cx="2295709" cy="183940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6AC6FF36-E730-4A35-A95D-F0617775A81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93" t="9930" r="7281" b="69222"/>
          <a:stretch/>
        </p:blipFill>
        <p:spPr>
          <a:xfrm>
            <a:off x="369574" y="311597"/>
            <a:ext cx="960709" cy="96070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9EC4851-63E7-4CB3-8595-0C4AAF446EB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14" t="41882" r="22742" b="37244"/>
          <a:stretch/>
        </p:blipFill>
        <p:spPr>
          <a:xfrm>
            <a:off x="1380484" y="310299"/>
            <a:ext cx="961921" cy="96192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9FF34CE-B11B-4604-987A-16C20F7F5676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70" t="70844" r="5505" b="8308"/>
          <a:stretch/>
        </p:blipFill>
        <p:spPr>
          <a:xfrm>
            <a:off x="371873" y="1317208"/>
            <a:ext cx="960708" cy="960708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3AA1F54-92A2-4526-9906-8A3AEFA66DDB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08" t="48170" r="60867" b="30982"/>
          <a:stretch/>
        </p:blipFill>
        <p:spPr>
          <a:xfrm>
            <a:off x="1381694" y="1317208"/>
            <a:ext cx="960708" cy="960708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B2B4113-5E88-4D9D-947F-7E141AE7993C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033" t="40283" r="22123" b="38843"/>
          <a:stretch/>
        </p:blipFill>
        <p:spPr>
          <a:xfrm>
            <a:off x="2434429" y="304979"/>
            <a:ext cx="961921" cy="961921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C7A78CA9-998C-4265-AD91-B88183A480BF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410" t="18970" r="3861" b="60318"/>
          <a:stretch/>
        </p:blipFill>
        <p:spPr>
          <a:xfrm>
            <a:off x="3435691" y="308704"/>
            <a:ext cx="954469" cy="954469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365AE206-ACA0-44E7-8D7A-BFB516C505B7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946" t="73111" r="40211" b="6015"/>
          <a:stretch/>
        </p:blipFill>
        <p:spPr>
          <a:xfrm>
            <a:off x="2433967" y="1317213"/>
            <a:ext cx="961921" cy="961921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DE9BB1ED-5E85-4B8D-B4CB-12D912645DBF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27" t="40949" r="54944" b="38338"/>
          <a:stretch/>
        </p:blipFill>
        <p:spPr>
          <a:xfrm>
            <a:off x="375812" y="2610229"/>
            <a:ext cx="954468" cy="954468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14B009A4-36BC-4A9B-8B9C-1960F23269BA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819" t="28262" r="21355" b="50890"/>
          <a:stretch/>
        </p:blipFill>
        <p:spPr>
          <a:xfrm>
            <a:off x="1378928" y="2602514"/>
            <a:ext cx="960709" cy="960709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189D6D81-C51A-472B-9037-7EDA37E1B4FB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98" t="29338" r="18273" b="49949"/>
          <a:stretch/>
        </p:blipFill>
        <p:spPr>
          <a:xfrm>
            <a:off x="378032" y="3608650"/>
            <a:ext cx="954468" cy="954468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FC845C5E-62D6-424D-96DD-B9AEF8E71803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13" t="62049" r="61261" b="17103"/>
          <a:stretch/>
        </p:blipFill>
        <p:spPr>
          <a:xfrm>
            <a:off x="1381699" y="3613702"/>
            <a:ext cx="960709" cy="960709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1A1BC59C-4CF8-4D8F-BCC9-7AD5EF231198}"/>
              </a:ext>
            </a:extLst>
          </p:cNvPr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84" t="65486" r="48887" b="13801"/>
          <a:stretch/>
        </p:blipFill>
        <p:spPr>
          <a:xfrm>
            <a:off x="2436053" y="2611137"/>
            <a:ext cx="954468" cy="954468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3813606B-0AE0-455B-AB97-3958E7FFE881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84" t="46268" r="33190" b="32884"/>
          <a:stretch/>
        </p:blipFill>
        <p:spPr>
          <a:xfrm>
            <a:off x="3441771" y="2602762"/>
            <a:ext cx="960709" cy="960709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2B75B70C-BD86-40C0-B979-C944F3D7BD4F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21" t="33675" r="59050" b="45612"/>
          <a:stretch/>
        </p:blipFill>
        <p:spPr>
          <a:xfrm>
            <a:off x="2432601" y="3619637"/>
            <a:ext cx="954468" cy="954468"/>
          </a:xfrm>
          <a:prstGeom prst="rect">
            <a:avLst/>
          </a:prstGeom>
        </p:spPr>
      </p:pic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49912035-CE84-46FF-999A-5EEFC2F54031}"/>
              </a:ext>
            </a:extLst>
          </p:cNvPr>
          <p:cNvCxnSpPr/>
          <p:nvPr/>
        </p:nvCxnSpPr>
        <p:spPr>
          <a:xfrm flipH="1">
            <a:off x="1907060" y="2912075"/>
            <a:ext cx="1812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F45C2C14-352E-4803-AB59-86CCDC05E575}"/>
              </a:ext>
            </a:extLst>
          </p:cNvPr>
          <p:cNvCxnSpPr/>
          <p:nvPr/>
        </p:nvCxnSpPr>
        <p:spPr>
          <a:xfrm flipH="1">
            <a:off x="1172972" y="1783491"/>
            <a:ext cx="18123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4861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16</TotalTime>
  <Words>26</Words>
  <Application>Microsoft Office PowerPoint</Application>
  <PresentationFormat>自定义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Xuewen</cp:lastModifiedBy>
  <cp:revision>76</cp:revision>
  <dcterms:created xsi:type="dcterms:W3CDTF">2020-09-04T01:35:22Z</dcterms:created>
  <dcterms:modified xsi:type="dcterms:W3CDTF">2020-10-11T19:03:47Z</dcterms:modified>
</cp:coreProperties>
</file>